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extLst>
    <p:ext uri="{E76CE94A-603C-4142-B9EB-6D1370010A27}">
      <p14:discardImageEditData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0"/>
    </p:ext>
    <p:ext uri="{D31A062A-798A-4329-ABDD-BBA856620510}">
      <p14:defaultImageDpi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>
      <p:cViewPr varScale="1">
        <p:scale>
          <a:sx n="143" d="100"/>
          <a:sy n="143" d="100"/>
        </p:scale>
        <p:origin x="-1352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fr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67EB5-3170-4886-A54E-67F48FBAB399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96A59-0C33-407C-A42A-A699287ACBA5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67EB5-3170-4886-A54E-67F48FBAB399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96A59-0C33-407C-A42A-A699287ACBA5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67EB5-3170-4886-A54E-67F48FBAB399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96A59-0C33-407C-A42A-A699287ACBA5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67EB5-3170-4886-A54E-67F48FBAB399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96A59-0C33-407C-A42A-A699287ACBA5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67EB5-3170-4886-A54E-67F48FBAB399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96A59-0C33-407C-A42A-A699287ACBA5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67EB5-3170-4886-A54E-67F48FBAB399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96A59-0C33-407C-A42A-A699287ACBA5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67EB5-3170-4886-A54E-67F48FBAB399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96A59-0C33-407C-A42A-A699287ACBA5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67EB5-3170-4886-A54E-67F48FBAB399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96A59-0C33-407C-A42A-A699287ACBA5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67EB5-3170-4886-A54E-67F48FBAB399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96A59-0C33-407C-A42A-A699287ACBA5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67EB5-3170-4886-A54E-67F48FBAB399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96A59-0C33-407C-A42A-A699287ACBA5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67EB5-3170-4886-A54E-67F48FBAB399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F96A59-0C33-407C-A42A-A699287ACBA5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467EB5-3170-4886-A54E-67F48FBAB399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F96A59-0C33-407C-A42A-A699287ACBA5}" type="slidenum">
              <a:rPr lang="fr-CA" smtClean="0"/>
              <a:pPr/>
              <a:t>‹#›</a:t>
            </a:fld>
            <a:endParaRPr lang="fr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402130388"/>
              </p:ext>
            </p:extLst>
          </p:nvPr>
        </p:nvGraphicFramePr>
        <p:xfrm>
          <a:off x="1857356" y="548712"/>
          <a:ext cx="5357850" cy="5688600"/>
        </p:xfrm>
        <a:graphic>
          <a:graphicData uri="http://schemas.openxmlformats.org/drawingml/2006/table">
            <a:tbl>
              <a:tblPr/>
              <a:tblGrid>
                <a:gridCol w="1093762"/>
                <a:gridCol w="1220575"/>
                <a:gridCol w="3043513"/>
              </a:tblGrid>
              <a:tr h="141532"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1532"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Gene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Direction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Sequence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4793"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1" u="none" strike="noStrike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Glut1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Forward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CTGGACCTCAAACTTCATTGTGGG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34793"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793"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Reverse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GGGTGTCTTGTCACTTTGGCTGG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793"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793"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1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Glut8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Forward</a:t>
                      </a:r>
                      <a:endParaRPr lang="fr-CA" sz="1200" b="0" i="0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ATGGACAGAGCAGGGCGAAG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793"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793"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Reverse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CCTACGTGGGAGGAGTTGCT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793"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793"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1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Hk2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Forward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CCGTGGTGGACAAGATAAGAGAGAACC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793"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793"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Reverse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GGACACGTCACATTTCGGAGCCAG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793"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793"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1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Aldo-A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Forward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GTGGGAAGAAGGAGAACCTG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793"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793"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Reverse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CTGGAGTGTTGATGGAGCAG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793"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793"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1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Ldha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Forward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TGTCTCCAGCAAAGACTACTGT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793"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793"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Reverse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GACTGTACTTGACAATGTTGGGA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793"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793"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1" u="none" strike="noStrike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Pdhk1</a:t>
                      </a:r>
                      <a:endParaRPr lang="fr-CA" sz="1200" b="0" i="1" u="none" strike="noStrike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Forward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ACAAGGAGAGCTTCGGGGTGGATC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793"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793"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Reverse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CCACGTCGCAGTTTGGATTTATGC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793"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793"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1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Rpl13A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Forward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AAGGCCAAGATGCACTATCG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793"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793">
                <a:tc>
                  <a:txBody>
                    <a:bodyPr/>
                    <a:lstStyle/>
                    <a:p>
                      <a:pPr algn="l" fontAlgn="b"/>
                      <a:endParaRPr lang="fr-CA" sz="1200" b="0" i="0" u="none" strike="noStrike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Reverse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GAGTCCGTTGGTCTTGAGGA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1532"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CA" sz="1200" b="0" i="0" u="none" strike="noStrike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6740" marR="6740" marT="67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6" name="Rectangle 5"/>
          <p:cNvSpPr/>
          <p:nvPr/>
        </p:nvSpPr>
        <p:spPr>
          <a:xfrm>
            <a:off x="1785950" y="355675"/>
            <a:ext cx="4572000" cy="307777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400" b="1">
                <a:latin typeface="Arial"/>
                <a:cs typeface="Arial"/>
              </a:rPr>
              <a:t>Table </a:t>
            </a:r>
            <a:r>
              <a:rPr lang="en-US" sz="1400" b="1" smtClean="0">
                <a:latin typeface="Arial"/>
                <a:cs typeface="Arial"/>
              </a:rPr>
              <a:t>S2. </a:t>
            </a:r>
            <a:r>
              <a:rPr lang="en-US" sz="1400" b="1" dirty="0">
                <a:latin typeface="Arial"/>
                <a:cs typeface="Arial"/>
              </a:rPr>
              <a:t>List of </a:t>
            </a:r>
            <a:r>
              <a:rPr lang="en-US" sz="1400" b="1" dirty="0" err="1">
                <a:latin typeface="Arial"/>
                <a:cs typeface="Arial"/>
              </a:rPr>
              <a:t>qPCR</a:t>
            </a:r>
            <a:r>
              <a:rPr lang="en-US" sz="1400" b="1" dirty="0">
                <a:latin typeface="Arial"/>
                <a:cs typeface="Arial"/>
              </a:rPr>
              <a:t> </a:t>
            </a:r>
            <a:r>
              <a:rPr lang="en-US" sz="1400" b="1" dirty="0" smtClean="0">
                <a:latin typeface="Arial"/>
                <a:cs typeface="Arial"/>
              </a:rPr>
              <a:t>primers</a:t>
            </a:r>
            <a:endParaRPr lang="fr-CA" sz="1400" dirty="0">
              <a:latin typeface="Arial"/>
              <a:cs typeface="Arial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7473152" y="6518248"/>
            <a:ext cx="16419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 err="1" smtClean="0">
                <a:latin typeface="Arial" pitchFamily="34" charset="0"/>
                <a:cs typeface="Arial" pitchFamily="34" charset="0"/>
              </a:rPr>
              <a:t>Dupuy</a:t>
            </a:r>
            <a:r>
              <a:rPr lang="en-CA" sz="14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CA" sz="1400" i="1" dirty="0" smtClean="0">
                <a:latin typeface="Arial" pitchFamily="34" charset="0"/>
                <a:cs typeface="Arial" pitchFamily="34" charset="0"/>
              </a:rPr>
              <a:t>et al</a:t>
            </a:r>
            <a:r>
              <a:rPr lang="en-CA" sz="1400" dirty="0" smtClean="0">
                <a:latin typeface="Arial" pitchFamily="34" charset="0"/>
                <a:cs typeface="Arial" pitchFamily="34" charset="0"/>
              </a:rPr>
              <a:t>., 2013</a:t>
            </a:r>
            <a:endParaRPr lang="en-CA" sz="14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56</Words>
  <Application>Microsoft Macintosh PowerPoint</Application>
  <PresentationFormat>On-screen Show (4:3)</PresentationFormat>
  <Paragraphs>43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Fanny</dc:creator>
  <cp:lastModifiedBy>Russell Jones</cp:lastModifiedBy>
  <cp:revision>5</cp:revision>
  <dcterms:created xsi:type="dcterms:W3CDTF">2013-07-10T16:20:48Z</dcterms:created>
  <dcterms:modified xsi:type="dcterms:W3CDTF">2013-07-10T16:21:02Z</dcterms:modified>
</cp:coreProperties>
</file>